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732" y="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m Xu" userId="0a1e7bf4-bae8-4174-b18b-2c367c304ef6" providerId="ADAL" clId="{D2C00FDE-7CDF-4FA1-A2C3-6D86DC18FF69}"/>
    <pc:docChg chg="modSld">
      <pc:chgData name="Sam Xu" userId="0a1e7bf4-bae8-4174-b18b-2c367c304ef6" providerId="ADAL" clId="{D2C00FDE-7CDF-4FA1-A2C3-6D86DC18FF69}" dt="2020-11-06T16:48:51.414" v="0" actId="20577"/>
      <pc:docMkLst>
        <pc:docMk/>
      </pc:docMkLst>
      <pc:sldChg chg="modSp mod">
        <pc:chgData name="Sam Xu" userId="0a1e7bf4-bae8-4174-b18b-2c367c304ef6" providerId="ADAL" clId="{D2C00FDE-7CDF-4FA1-A2C3-6D86DC18FF69}" dt="2020-11-06T16:48:51.414" v="0" actId="20577"/>
        <pc:sldMkLst>
          <pc:docMk/>
          <pc:sldMk cId="385347903" sldId="257"/>
        </pc:sldMkLst>
        <pc:spChg chg="mod">
          <ac:chgData name="Sam Xu" userId="0a1e7bf4-bae8-4174-b18b-2c367c304ef6" providerId="ADAL" clId="{D2C00FDE-7CDF-4FA1-A2C3-6D86DC18FF69}" dt="2020-11-06T16:48:51.414" v="0" actId="20577"/>
          <ac:spMkLst>
            <pc:docMk/>
            <pc:sldMk cId="385347903" sldId="257"/>
            <ac:spMk id="34" creationId="{FCC68F4B-DE02-4436-90FB-6DEDFAEB3D87}"/>
          </ac:spMkLst>
        </pc:spChg>
      </pc:sldChg>
    </pc:docChg>
  </pc:docChgLst>
  <pc:docChgLst>
    <pc:chgData name="Sam Xu" userId="0a1e7bf4-bae8-4174-b18b-2c367c304ef6" providerId="ADAL" clId="{A9EDE272-3079-43DD-92D5-043D6C98B4CA}"/>
    <pc:docChg chg="modSld">
      <pc:chgData name="Sam Xu" userId="0a1e7bf4-bae8-4174-b18b-2c367c304ef6" providerId="ADAL" clId="{A9EDE272-3079-43DD-92D5-043D6C98B4CA}" dt="2020-10-29T11:59:58.342" v="4" actId="1076"/>
      <pc:docMkLst>
        <pc:docMk/>
      </pc:docMkLst>
      <pc:sldChg chg="addSp modSp mod">
        <pc:chgData name="Sam Xu" userId="0a1e7bf4-bae8-4174-b18b-2c367c304ef6" providerId="ADAL" clId="{A9EDE272-3079-43DD-92D5-043D6C98B4CA}" dt="2020-10-29T11:59:58.342" v="4" actId="1076"/>
        <pc:sldMkLst>
          <pc:docMk/>
          <pc:sldMk cId="385347903" sldId="257"/>
        </pc:sldMkLst>
        <pc:picChg chg="add mod">
          <ac:chgData name="Sam Xu" userId="0a1e7bf4-bae8-4174-b18b-2c367c304ef6" providerId="ADAL" clId="{A9EDE272-3079-43DD-92D5-043D6C98B4CA}" dt="2020-10-29T11:58:52.487" v="3" actId="1076"/>
          <ac:picMkLst>
            <pc:docMk/>
            <pc:sldMk cId="385347903" sldId="257"/>
            <ac:picMk id="3" creationId="{9812DF8F-4D52-490F-99BB-A7FE5F0BC806}"/>
          </ac:picMkLst>
        </pc:picChg>
        <pc:picChg chg="mod">
          <ac:chgData name="Sam Xu" userId="0a1e7bf4-bae8-4174-b18b-2c367c304ef6" providerId="ADAL" clId="{A9EDE272-3079-43DD-92D5-043D6C98B4CA}" dt="2020-10-29T11:59:58.342" v="4" actId="1076"/>
          <ac:picMkLst>
            <pc:docMk/>
            <pc:sldMk cId="385347903" sldId="257"/>
            <ac:picMk id="22" creationId="{00000000-0000-0000-0000-00000000000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10D9D0-2709-450D-B9DE-606A359204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12F78D5-DE97-4D6C-922B-1835BFFE16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716BA4-B2CD-48BA-A87E-C20BB9101C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CEED9-D02C-4B96-8F30-46031FE9E573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9DE10C-2579-4F67-9865-C188B15C9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240DBA-B08C-422D-8580-F916C6363A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86DF2-C60C-467C-A788-F6025F2D5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885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618B49-243E-4D16-9E54-CAE8E4F2E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7CF74-D915-4615-A429-452BCDD2F2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89F76C-A7BE-46C5-B783-0ECB9B7B8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CEED9-D02C-4B96-8F30-46031FE9E573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85E954-5C4D-4715-88F9-D8B83AFF8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3FAFA6-CEA8-43E4-995B-18BF16FCB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86DF2-C60C-467C-A788-F6025F2D5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001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EC108B9-3EC6-467C-A4EF-7D45F0BF63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451E58-D33B-47B6-99A7-13F00A43CA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02F000-923B-46DD-A5B4-763748EEB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CEED9-D02C-4B96-8F30-46031FE9E573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465964-0084-4C0E-BA13-66BEC9D4C2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90B582-5ADB-4019-9FEB-47DDA6F7C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86DF2-C60C-467C-A788-F6025F2D5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252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21BDC7-1ABB-49BB-968A-172EBD6FB1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0D9FE6-928C-4EA6-B824-0AB3B5F2FE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1D89BD-2D66-48F4-9D6C-C4C567BC5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CEED9-D02C-4B96-8F30-46031FE9E573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4D5638-B886-4A3C-A2BD-BF1BABE708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E0178D-AF96-45ED-BD64-110F14297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86DF2-C60C-467C-A788-F6025F2D5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585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419A9-82F1-4393-97AE-5B4030B143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D61259-1189-488D-A996-40D0B98A17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44D2C2-12A6-4DF1-A7FD-8037EF431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CEED9-D02C-4B96-8F30-46031FE9E573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293A2F-6383-4DD8-91B2-BB3E21117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E71804-F941-4B8E-9314-6EEFF8DE1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86DF2-C60C-467C-A788-F6025F2D5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403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EB534D-2B0E-471E-A424-642EDC90B4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2DED8F-F3E8-4C37-92F7-618C2A810D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C4B858-2656-4B36-8C5A-95C8489674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42DA8D-0459-42EF-9B3A-048F8A285D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CEED9-D02C-4B96-8F30-46031FE9E573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DD02D6-0D00-479C-B25A-0051F6607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3C1F3B-3855-4D46-92AC-0A2E15611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86DF2-C60C-467C-A788-F6025F2D5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51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07BA42-CDAA-4F02-8404-92C873AAB6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90EA25-5314-4168-A17D-923B8A9632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918CB4-AD22-4791-86DD-747AA99C6A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0A0D69-4DC4-4FE5-9DF7-3FDB79BF69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35BE49F-A6B6-494A-AF3E-6A44FEF1AD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1B3EB7-809D-4887-84FD-7C2DF7A7C1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CEED9-D02C-4B96-8F30-46031FE9E573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99B8DF3-D5E2-4173-9D20-811FC2E19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09BF22A-1995-4BF2-9CB1-87F47323D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86DF2-C60C-467C-A788-F6025F2D5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659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A6835-7F18-45B2-B027-4C7FA043CA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A2A8D60-27B7-4FA9-BF2C-649E408AA6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CEED9-D02C-4B96-8F30-46031FE9E573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3107BC-3D3C-44F7-BF1B-D23F529FE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0FBE08-B6CB-4703-9087-513C8492D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86DF2-C60C-467C-A788-F6025F2D5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183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BEE52CC-CD0F-4EBF-BBAA-218C15BFA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CEED9-D02C-4B96-8F30-46031FE9E573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D64CE2E-0368-4B26-B0F9-9FDB78A459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844987-50BC-4844-A9C9-70ADFA1438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86DF2-C60C-467C-A788-F6025F2D5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7998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4B24E4-D9DD-4564-918C-36089B4289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76FEF8-8D12-4A53-9E81-F16B64EB49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05E923-D86A-47BD-AE22-C2EDE4DBB6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18A3B8-6720-432C-A0F3-61DA874E2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CEED9-D02C-4B96-8F30-46031FE9E573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5C60A2-3EA0-420F-94A6-3FE7B3219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6B1906-16B7-4C6D-AB85-2393331F1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86DF2-C60C-467C-A788-F6025F2D5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532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BF0793-4C59-42E5-AF8C-6C3719D70E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9752EAD-CF81-428D-B77E-DF35BE5F86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26EEDF-ABBD-4F1E-85A5-E66F0C2E03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4EB3EB-94B9-4C25-9668-C50413DDB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CEED9-D02C-4B96-8F30-46031FE9E573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6609CB-8784-4E83-89D1-C4C8E49AA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2AE3CB-D2D7-4DF3-B908-3A4E09E7D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86DF2-C60C-467C-A788-F6025F2D5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86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4DD33C-C6A9-4378-87C4-4596835597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275F81-7E37-4412-9A3C-C6D04F919A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3940D6-E265-41BF-AA9E-C0CACEC6B9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3CEED9-D02C-4B96-8F30-46031FE9E573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EA7878-92FF-4160-B073-A3698D535B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87D460-EB29-41D4-A279-4D52DE4883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86DF2-C60C-467C-A788-F6025F2D5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073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sitting, dark, bench, light&#10;&#10;Description automatically generated">
            <a:extLst>
              <a:ext uri="{FF2B5EF4-FFF2-40B4-BE49-F238E27FC236}">
                <a16:creationId xmlns:a16="http://schemas.microsoft.com/office/drawing/2014/main" id="{9812DF8F-4D52-490F-99BB-A7FE5F0BC8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4321" y="1281654"/>
            <a:ext cx="3533775" cy="3670816"/>
          </a:xfrm>
          <a:prstGeom prst="rect">
            <a:avLst/>
          </a:prstGeom>
        </p:spPr>
      </p:pic>
      <p:sp>
        <p:nvSpPr>
          <p:cNvPr id="9" name="Text Box 122">
            <a:extLst>
              <a:ext uri="{FF2B5EF4-FFF2-40B4-BE49-F238E27FC236}">
                <a16:creationId xmlns:a16="http://schemas.microsoft.com/office/drawing/2014/main" id="{ADDFF10C-99A5-425D-A6DE-86076440FF97}"/>
              </a:ext>
            </a:extLst>
          </p:cNvPr>
          <p:cNvSpPr txBox="1"/>
          <p:nvPr/>
        </p:nvSpPr>
        <p:spPr>
          <a:xfrm rot="2700000">
            <a:off x="6514600" y="441140"/>
            <a:ext cx="353943" cy="94562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GLT-2 (P1)</a:t>
            </a:r>
            <a:endParaRPr lang="en-GB" sz="11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0" name="Text Box 123">
            <a:extLst>
              <a:ext uri="{FF2B5EF4-FFF2-40B4-BE49-F238E27FC236}">
                <a16:creationId xmlns:a16="http://schemas.microsoft.com/office/drawing/2014/main" id="{A082B38F-CA1F-4614-B5F2-E541C4D553CE}"/>
              </a:ext>
            </a:extLst>
          </p:cNvPr>
          <p:cNvSpPr txBox="1"/>
          <p:nvPr/>
        </p:nvSpPr>
        <p:spPr>
          <a:xfrm>
            <a:off x="8110139" y="1527782"/>
            <a:ext cx="7716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100" b="1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p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n-GB" sz="11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1" name="Text Box 124">
            <a:extLst>
              <a:ext uri="{FF2B5EF4-FFF2-40B4-BE49-F238E27FC236}">
                <a16:creationId xmlns:a16="http://schemas.microsoft.com/office/drawing/2014/main" id="{AA94DA87-F39E-46BD-B1EF-938DEAE56043}"/>
              </a:ext>
            </a:extLst>
          </p:cNvPr>
          <p:cNvSpPr txBox="1"/>
          <p:nvPr/>
        </p:nvSpPr>
        <p:spPr>
          <a:xfrm>
            <a:off x="7984632" y="2269397"/>
            <a:ext cx="9840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1,500</a:t>
            </a:r>
            <a:endParaRPr lang="en-GB" sz="1100" b="1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2" name="Text Box 125">
            <a:extLst>
              <a:ext uri="{FF2B5EF4-FFF2-40B4-BE49-F238E27FC236}">
                <a16:creationId xmlns:a16="http://schemas.microsoft.com/office/drawing/2014/main" id="{EBBE4D75-F210-4F80-9C82-F086EA120E3D}"/>
              </a:ext>
            </a:extLst>
          </p:cNvPr>
          <p:cNvSpPr txBox="1"/>
          <p:nvPr/>
        </p:nvSpPr>
        <p:spPr>
          <a:xfrm>
            <a:off x="7994513" y="3146627"/>
            <a:ext cx="6829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500</a:t>
            </a:r>
            <a:endParaRPr lang="en-GB" sz="1100" b="1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3" name="Text Box 126">
            <a:extLst>
              <a:ext uri="{FF2B5EF4-FFF2-40B4-BE49-F238E27FC236}">
                <a16:creationId xmlns:a16="http://schemas.microsoft.com/office/drawing/2014/main" id="{13091172-C72F-4DC8-A54E-B7B238077409}"/>
              </a:ext>
            </a:extLst>
          </p:cNvPr>
          <p:cNvSpPr txBox="1"/>
          <p:nvPr/>
        </p:nvSpPr>
        <p:spPr>
          <a:xfrm>
            <a:off x="7985484" y="3368137"/>
            <a:ext cx="5723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400</a:t>
            </a:r>
            <a:endParaRPr lang="en-GB" sz="1100" b="1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4" name="Text Box 127">
            <a:extLst>
              <a:ext uri="{FF2B5EF4-FFF2-40B4-BE49-F238E27FC236}">
                <a16:creationId xmlns:a16="http://schemas.microsoft.com/office/drawing/2014/main" id="{C64C30BA-2AF5-4543-AB48-8102F223DAF1}"/>
              </a:ext>
            </a:extLst>
          </p:cNvPr>
          <p:cNvSpPr txBox="1"/>
          <p:nvPr/>
        </p:nvSpPr>
        <p:spPr>
          <a:xfrm>
            <a:off x="7991614" y="3616908"/>
            <a:ext cx="6860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300</a:t>
            </a:r>
            <a:endParaRPr lang="en-GB" sz="1100" b="1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5" name="Text Box 128">
            <a:extLst>
              <a:ext uri="{FF2B5EF4-FFF2-40B4-BE49-F238E27FC236}">
                <a16:creationId xmlns:a16="http://schemas.microsoft.com/office/drawing/2014/main" id="{748FCBAA-6AA3-453A-914D-25B5A06F9C13}"/>
              </a:ext>
            </a:extLst>
          </p:cNvPr>
          <p:cNvSpPr txBox="1"/>
          <p:nvPr/>
        </p:nvSpPr>
        <p:spPr>
          <a:xfrm>
            <a:off x="7989853" y="3946897"/>
            <a:ext cx="6781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200</a:t>
            </a:r>
            <a:endParaRPr lang="en-GB" sz="11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6" name="Text Box 129">
            <a:extLst>
              <a:ext uri="{FF2B5EF4-FFF2-40B4-BE49-F238E27FC236}">
                <a16:creationId xmlns:a16="http://schemas.microsoft.com/office/drawing/2014/main" id="{DC7A69BE-B517-44CC-AE20-1019976962D8}"/>
              </a:ext>
            </a:extLst>
          </p:cNvPr>
          <p:cNvSpPr txBox="1"/>
          <p:nvPr/>
        </p:nvSpPr>
        <p:spPr>
          <a:xfrm>
            <a:off x="7986423" y="4331865"/>
            <a:ext cx="6816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100</a:t>
            </a:r>
            <a:endParaRPr lang="en-GB" sz="1100" b="1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7" name="Text Box 130">
            <a:extLst>
              <a:ext uri="{FF2B5EF4-FFF2-40B4-BE49-F238E27FC236}">
                <a16:creationId xmlns:a16="http://schemas.microsoft.com/office/drawing/2014/main" id="{B653AB57-5C57-4B8B-905D-9604BB2EF3DC}"/>
              </a:ext>
            </a:extLst>
          </p:cNvPr>
          <p:cNvSpPr txBox="1"/>
          <p:nvPr/>
        </p:nvSpPr>
        <p:spPr>
          <a:xfrm rot="2700000">
            <a:off x="6806931" y="435833"/>
            <a:ext cx="353943" cy="95103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GLT-2 (P2)</a:t>
            </a:r>
            <a:endParaRPr lang="en-GB" sz="11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8" name="Text Box 132">
            <a:extLst>
              <a:ext uri="{FF2B5EF4-FFF2-40B4-BE49-F238E27FC236}">
                <a16:creationId xmlns:a16="http://schemas.microsoft.com/office/drawing/2014/main" id="{286347E5-D677-453A-8EC1-1933DC7A5D1C}"/>
              </a:ext>
            </a:extLst>
          </p:cNvPr>
          <p:cNvSpPr txBox="1"/>
          <p:nvPr/>
        </p:nvSpPr>
        <p:spPr>
          <a:xfrm rot="18900000">
            <a:off x="7061819" y="812296"/>
            <a:ext cx="765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β-actin</a:t>
            </a:r>
            <a:endParaRPr lang="en-GB" sz="11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9" name="Text Box 132">
            <a:extLst>
              <a:ext uri="{FF2B5EF4-FFF2-40B4-BE49-F238E27FC236}">
                <a16:creationId xmlns:a16="http://schemas.microsoft.com/office/drawing/2014/main" id="{B6793FF8-E216-438D-9434-3A111A24F7CC}"/>
              </a:ext>
            </a:extLst>
          </p:cNvPr>
          <p:cNvSpPr txBox="1"/>
          <p:nvPr/>
        </p:nvSpPr>
        <p:spPr>
          <a:xfrm rot="18900000">
            <a:off x="7357502" y="820017"/>
            <a:ext cx="7734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rker</a:t>
            </a:r>
            <a:endParaRPr lang="en-GB" sz="11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20" name="Text Box 130">
            <a:extLst>
              <a:ext uri="{FF2B5EF4-FFF2-40B4-BE49-F238E27FC236}">
                <a16:creationId xmlns:a16="http://schemas.microsoft.com/office/drawing/2014/main" id="{61FCD52B-1E45-45B0-ADB0-A04069C0243B}"/>
              </a:ext>
            </a:extLst>
          </p:cNvPr>
          <p:cNvSpPr txBox="1"/>
          <p:nvPr/>
        </p:nvSpPr>
        <p:spPr>
          <a:xfrm rot="2700000">
            <a:off x="7078998" y="428904"/>
            <a:ext cx="353943" cy="95103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GLT-1</a:t>
            </a:r>
            <a:endParaRPr lang="en-GB" sz="11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21" name="Text Box 124">
            <a:extLst>
              <a:ext uri="{FF2B5EF4-FFF2-40B4-BE49-F238E27FC236}">
                <a16:creationId xmlns:a16="http://schemas.microsoft.com/office/drawing/2014/main" id="{57F8637E-8026-447E-AC97-5CDBA38E510F}"/>
              </a:ext>
            </a:extLst>
          </p:cNvPr>
          <p:cNvSpPr txBox="1"/>
          <p:nvPr/>
        </p:nvSpPr>
        <p:spPr>
          <a:xfrm>
            <a:off x="7992294" y="2534259"/>
            <a:ext cx="9840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1,000</a:t>
            </a:r>
            <a:endParaRPr lang="en-GB" sz="11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2" name="Text Box 122">
            <a:extLst>
              <a:ext uri="{FF2B5EF4-FFF2-40B4-BE49-F238E27FC236}">
                <a16:creationId xmlns:a16="http://schemas.microsoft.com/office/drawing/2014/main" id="{608DE2C2-FB8B-430D-BE0A-1C41773D7822}"/>
              </a:ext>
            </a:extLst>
          </p:cNvPr>
          <p:cNvSpPr txBox="1"/>
          <p:nvPr/>
        </p:nvSpPr>
        <p:spPr>
          <a:xfrm rot="2700000">
            <a:off x="5060834" y="442471"/>
            <a:ext cx="353943" cy="94562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GLT-2 (P1)</a:t>
            </a:r>
            <a:endParaRPr lang="en-GB" sz="11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5" name="Text Box 130">
            <a:extLst>
              <a:ext uri="{FF2B5EF4-FFF2-40B4-BE49-F238E27FC236}">
                <a16:creationId xmlns:a16="http://schemas.microsoft.com/office/drawing/2014/main" id="{F315C20C-93E4-4881-8139-079E0DEC0406}"/>
              </a:ext>
            </a:extLst>
          </p:cNvPr>
          <p:cNvSpPr txBox="1"/>
          <p:nvPr/>
        </p:nvSpPr>
        <p:spPr>
          <a:xfrm rot="2700000">
            <a:off x="5353165" y="437164"/>
            <a:ext cx="353943" cy="95103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GLT-2 (P2)</a:t>
            </a:r>
            <a:endParaRPr lang="en-GB" sz="11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28" name="Text Box 132">
            <a:extLst>
              <a:ext uri="{FF2B5EF4-FFF2-40B4-BE49-F238E27FC236}">
                <a16:creationId xmlns:a16="http://schemas.microsoft.com/office/drawing/2014/main" id="{94B2CBE3-0120-45AF-86A3-2D9937A0C2B3}"/>
              </a:ext>
            </a:extLst>
          </p:cNvPr>
          <p:cNvSpPr txBox="1"/>
          <p:nvPr/>
        </p:nvSpPr>
        <p:spPr>
          <a:xfrm rot="18900000">
            <a:off x="5608053" y="813627"/>
            <a:ext cx="765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β-actin</a:t>
            </a:r>
            <a:endParaRPr lang="en-GB" sz="11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32" name="Text Box 130">
            <a:extLst>
              <a:ext uri="{FF2B5EF4-FFF2-40B4-BE49-F238E27FC236}">
                <a16:creationId xmlns:a16="http://schemas.microsoft.com/office/drawing/2014/main" id="{74B441F1-089B-42D5-93F5-88EC9E95C47A}"/>
              </a:ext>
            </a:extLst>
          </p:cNvPr>
          <p:cNvSpPr txBox="1"/>
          <p:nvPr/>
        </p:nvSpPr>
        <p:spPr>
          <a:xfrm rot="2700000">
            <a:off x="5625232" y="430235"/>
            <a:ext cx="353943" cy="95103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GLT-1</a:t>
            </a:r>
            <a:endParaRPr lang="en-GB" sz="11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57CF4A5B-D939-48B7-9765-1334C6963301}"/>
              </a:ext>
            </a:extLst>
          </p:cNvPr>
          <p:cNvSpPr/>
          <p:nvPr/>
        </p:nvSpPr>
        <p:spPr>
          <a:xfrm>
            <a:off x="6232103" y="1851461"/>
            <a:ext cx="1485245" cy="2798859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CC68F4B-DE02-4436-90FB-6DEDFAEB3D87}"/>
              </a:ext>
            </a:extLst>
          </p:cNvPr>
          <p:cNvSpPr txBox="1"/>
          <p:nvPr/>
        </p:nvSpPr>
        <p:spPr>
          <a:xfrm>
            <a:off x="3560812" y="5978535"/>
            <a:ext cx="71583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1 Fig. The full PCR gel and the cropped area (boxed) presented in Figur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5347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56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 Xu</dc:creator>
  <cp:lastModifiedBy>Sam Xu</cp:lastModifiedBy>
  <cp:revision>3</cp:revision>
  <dcterms:created xsi:type="dcterms:W3CDTF">2020-10-29T11:57:22Z</dcterms:created>
  <dcterms:modified xsi:type="dcterms:W3CDTF">2020-11-06T16:49:10Z</dcterms:modified>
</cp:coreProperties>
</file>